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5" d="100"/>
          <a:sy n="85" d="100"/>
        </p:scale>
        <p:origin x="264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ipssmonstera\doan\Switzerland%202017\Ph.D%20project\Christelle%20project\Priming%20project\Priming%20story%20190506\New%20Microsoft%20Excel%20Workshee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ipssmonstera\ChemEcol\2017.%20Cong\01.%20Chapter%20I_Priming\Data\04.%20HIPVs%20on%20larval%20performance\Supl2.%20experiment%20expose%20to%20three%20neighbour%20plan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ipssmonstera\ChemEcol\2017.%20Cong\01.%20Chapter%20I_Priming\Data\04.%20HIPVs%20on%20larval%20performance\Supl2.%20experiment%20expose%20to%20three%20neighbour%20plan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ipssmonstera\ChemEcol\2017.%20Cong\01.%20Chapter%20I_Priming\Data\04.%20HIPVs%20on%20larval%20performance\Supl2.%20experiment%20expose%20to%20three%20neighbour%20plant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3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6:$F$6</c:f>
                <c:numCache>
                  <c:formatCode>General</c:formatCode>
                  <c:ptCount val="5"/>
                  <c:pt idx="0">
                    <c:v>4.4444444440000002</c:v>
                  </c:pt>
                  <c:pt idx="1">
                    <c:v>9.3128081189999996</c:v>
                  </c:pt>
                  <c:pt idx="2">
                    <c:v>8.0315734970000001</c:v>
                  </c:pt>
                  <c:pt idx="3">
                    <c:v>8.766518799</c:v>
                  </c:pt>
                  <c:pt idx="4">
                    <c:v>8.6245414979999993</c:v>
                  </c:pt>
                </c:numCache>
              </c:numRef>
            </c:plus>
            <c:minus>
              <c:numRef>
                <c:f>Sheet1!$B$6:$F$6</c:f>
                <c:numCache>
                  <c:formatCode>General</c:formatCode>
                  <c:ptCount val="5"/>
                  <c:pt idx="0">
                    <c:v>4.4444444440000002</c:v>
                  </c:pt>
                  <c:pt idx="1">
                    <c:v>9.3128081189999996</c:v>
                  </c:pt>
                  <c:pt idx="2">
                    <c:v>8.0315734970000001</c:v>
                  </c:pt>
                  <c:pt idx="3">
                    <c:v>8.766518799</c:v>
                  </c:pt>
                  <c:pt idx="4">
                    <c:v>8.62454149799999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Sheet1!$B$4:$F$4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</c:numCache>
            </c:numRef>
          </c:xVal>
          <c:yVal>
            <c:numRef>
              <c:f>Sheet1!$B$5:$F$5</c:f>
              <c:numCache>
                <c:formatCode>General</c:formatCode>
                <c:ptCount val="5"/>
                <c:pt idx="0">
                  <c:v>23.3</c:v>
                </c:pt>
                <c:pt idx="1">
                  <c:v>45</c:v>
                </c:pt>
                <c:pt idx="2">
                  <c:v>65</c:v>
                </c:pt>
                <c:pt idx="3">
                  <c:v>68.3</c:v>
                </c:pt>
                <c:pt idx="4">
                  <c:v>7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15C-4CEB-AD78-870799E738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3714432"/>
        <c:axId val="423714992"/>
      </c:scatterChart>
      <c:valAx>
        <c:axId val="423714432"/>
        <c:scaling>
          <c:orientation val="minMax"/>
          <c:max val="6.5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dirty="0"/>
                  <a:t>Day after </a:t>
                </a:r>
                <a:r>
                  <a:rPr lang="en-GB" dirty="0" smtClean="0"/>
                  <a:t>infestation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23714992"/>
        <c:crosses val="autoZero"/>
        <c:crossBetween val="midCat"/>
        <c:majorUnit val="1"/>
      </c:valAx>
      <c:valAx>
        <c:axId val="423714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dirty="0" smtClean="0"/>
                  <a:t>Larval escape </a:t>
                </a:r>
                <a:r>
                  <a:rPr lang="en-GB" dirty="0"/>
                  <a:t>[%]</a:t>
                </a:r>
              </a:p>
            </c:rich>
          </c:tx>
          <c:layout>
            <c:manualLayout>
              <c:xMode val="edge"/>
              <c:yMode val="edge"/>
              <c:x val="3.4810149351301216E-2"/>
              <c:y val="4.8191500125941613E-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23714432"/>
        <c:crosses val="autoZero"/>
        <c:crossBetween val="midCat"/>
        <c:majorUnit val="3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ool Cong1 and CA2'!$P$4</c:f>
              <c:strCache>
                <c:ptCount val="1"/>
                <c:pt idx="0">
                  <c:v>gain weigh (%)</c:v>
                </c:pt>
              </c:strCache>
            </c:strRef>
          </c:tx>
          <c:spPr>
            <a:solidFill>
              <a:srgbClr val="ED7D3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70AD47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1C7-41CA-99D0-F2937E91BAF0}"/>
              </c:ext>
            </c:extLst>
          </c:dPt>
          <c:errBars>
            <c:errBarType val="both"/>
            <c:errValType val="cust"/>
            <c:noEndCap val="0"/>
            <c:plus>
              <c:numRef>
                <c:f>'pool Cong1 and CA2'!$P$8:$P$9</c:f>
                <c:numCache>
                  <c:formatCode>General</c:formatCode>
                  <c:ptCount val="2"/>
                  <c:pt idx="0">
                    <c:v>32.897267240286709</c:v>
                  </c:pt>
                  <c:pt idx="1">
                    <c:v>33.143557174407846</c:v>
                  </c:pt>
                </c:numCache>
              </c:numRef>
            </c:plus>
            <c:minus>
              <c:numRef>
                <c:f>'pool Cong1 and CA2'!$P$8:$P$9</c:f>
                <c:numCache>
                  <c:formatCode>General</c:formatCode>
                  <c:ptCount val="2"/>
                  <c:pt idx="0">
                    <c:v>32.897267240286709</c:v>
                  </c:pt>
                  <c:pt idx="1">
                    <c:v>33.1435571744078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ool Cong1 and CA2'!$N$5:$N$6</c:f>
              <c:strCache>
                <c:ptCount val="2"/>
                <c:pt idx="0">
                  <c:v>Control</c:v>
                </c:pt>
                <c:pt idx="1">
                  <c:v>Induced</c:v>
                </c:pt>
              </c:strCache>
            </c:strRef>
          </c:cat>
          <c:val>
            <c:numRef>
              <c:f>'pool Cong1 and CA2'!$P$5:$P$6</c:f>
              <c:numCache>
                <c:formatCode>General</c:formatCode>
                <c:ptCount val="2"/>
                <c:pt idx="0" formatCode="0.00">
                  <c:v>140.71210991727264</c:v>
                </c:pt>
                <c:pt idx="1">
                  <c:v>140.549997970375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1C7-41CA-99D0-F2937E91BA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854855216"/>
        <c:axId val="854855776"/>
      </c:barChart>
      <c:catAx>
        <c:axId val="854855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54855776"/>
        <c:crosses val="autoZero"/>
        <c:auto val="1"/>
        <c:lblAlgn val="ctr"/>
        <c:lblOffset val="100"/>
        <c:noMultiLvlLbl val="0"/>
      </c:catAx>
      <c:valAx>
        <c:axId val="854855776"/>
        <c:scaling>
          <c:orientation val="minMax"/>
          <c:max val="2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CH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rval</a:t>
                </a:r>
                <a:r>
                  <a:rPr lang="de-CH" sz="11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100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eight</a:t>
                </a:r>
                <a:r>
                  <a:rPr lang="de-CH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100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in</a:t>
                </a:r>
                <a:r>
                  <a:rPr lang="de-CH" sz="11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  <a:endParaRPr lang="de-CH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54855216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ool Cong1 and CA2'!$Q$4</c:f>
              <c:strCache>
                <c:ptCount val="1"/>
                <c:pt idx="0">
                  <c:v>Recver (%)</c:v>
                </c:pt>
              </c:strCache>
            </c:strRef>
          </c:tx>
          <c:spPr>
            <a:solidFill>
              <a:srgbClr val="5B9BD5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70AD47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6B6-4EE9-B39F-56594614B570}"/>
              </c:ext>
            </c:extLst>
          </c:dPt>
          <c:dPt>
            <c:idx val="1"/>
            <c:invertIfNegative val="0"/>
            <c:bubble3D val="0"/>
            <c:spPr>
              <a:solidFill>
                <a:srgbClr val="ED7D3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6B6-4EE9-B39F-56594614B570}"/>
              </c:ext>
            </c:extLst>
          </c:dPt>
          <c:errBars>
            <c:errBarType val="both"/>
            <c:errValType val="cust"/>
            <c:noEndCap val="0"/>
            <c:plus>
              <c:numRef>
                <c:f>'pool Cong1 and CA2'!$Q$8:$Q$9</c:f>
                <c:numCache>
                  <c:formatCode>General</c:formatCode>
                  <c:ptCount val="2"/>
                  <c:pt idx="0">
                    <c:v>8.7841046115788313</c:v>
                  </c:pt>
                  <c:pt idx="1">
                    <c:v>8.7841046115788313</c:v>
                  </c:pt>
                </c:numCache>
              </c:numRef>
            </c:plus>
            <c:minus>
              <c:numRef>
                <c:f>'pool Cong1 and CA2'!$Q$8:$Q$9</c:f>
                <c:numCache>
                  <c:formatCode>General</c:formatCode>
                  <c:ptCount val="2"/>
                  <c:pt idx="0">
                    <c:v>8.7841046115788313</c:v>
                  </c:pt>
                  <c:pt idx="1">
                    <c:v>8.78410461157883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ool Cong1 and CA2'!$N$5:$N$6</c:f>
              <c:strCache>
                <c:ptCount val="2"/>
                <c:pt idx="0">
                  <c:v>Control</c:v>
                </c:pt>
                <c:pt idx="1">
                  <c:v>Induced</c:v>
                </c:pt>
              </c:strCache>
            </c:strRef>
          </c:cat>
          <c:val>
            <c:numRef>
              <c:f>'pool Cong1 and CA2'!$Q$5:$Q$6</c:f>
              <c:numCache>
                <c:formatCode>General</c:formatCode>
                <c:ptCount val="2"/>
                <c:pt idx="0">
                  <c:v>72.222222222222229</c:v>
                </c:pt>
                <c:pt idx="1">
                  <c:v>70.3703703703703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6B6-4EE9-B39F-56594614B5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854858576"/>
        <c:axId val="847007040"/>
      </c:barChart>
      <c:catAx>
        <c:axId val="854858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47007040"/>
        <c:crosses val="autoZero"/>
        <c:auto val="1"/>
        <c:lblAlgn val="ctr"/>
        <c:lblOffset val="100"/>
        <c:noMultiLvlLbl val="0"/>
      </c:catAx>
      <c:valAx>
        <c:axId val="847007040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CH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rval </a:t>
                </a:r>
                <a:r>
                  <a:rPr lang="de-CH" sz="1100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rvival</a:t>
                </a:r>
                <a:r>
                  <a:rPr lang="de-CH" sz="11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  <a:endParaRPr lang="de-CH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85485857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ool Cong1 and CA2'!$O$4</c:f>
              <c:strCache>
                <c:ptCount val="1"/>
                <c:pt idx="0">
                  <c:v>total root weight (mg)</c:v>
                </c:pt>
              </c:strCache>
            </c:strRef>
          </c:tx>
          <c:spPr>
            <a:solidFill>
              <a:srgbClr val="70AD47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ED7D3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447-43E6-9E01-C5AA4C14FBE2}"/>
              </c:ext>
            </c:extLst>
          </c:dPt>
          <c:errBars>
            <c:errBarType val="both"/>
            <c:errValType val="cust"/>
            <c:noEndCap val="0"/>
            <c:plus>
              <c:numRef>
                <c:f>'pool Cong1 and CA2'!$O$14:$O$15</c:f>
                <c:numCache>
                  <c:formatCode>General</c:formatCode>
                  <c:ptCount val="2"/>
                  <c:pt idx="0">
                    <c:v>0.21566265953115143</c:v>
                  </c:pt>
                  <c:pt idx="1">
                    <c:v>0.21401785433768997</c:v>
                  </c:pt>
                </c:numCache>
              </c:numRef>
            </c:plus>
            <c:minus>
              <c:numRef>
                <c:f>'pool Cong1 and CA2'!$O$14:$O$15</c:f>
                <c:numCache>
                  <c:formatCode>General</c:formatCode>
                  <c:ptCount val="2"/>
                  <c:pt idx="0">
                    <c:v>0.21566265953115143</c:v>
                  </c:pt>
                  <c:pt idx="1">
                    <c:v>0.214017854337689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ool Cong1 and CA2'!$N$5:$N$6</c:f>
              <c:strCache>
                <c:ptCount val="2"/>
                <c:pt idx="0">
                  <c:v>Control</c:v>
                </c:pt>
                <c:pt idx="1">
                  <c:v>Induced</c:v>
                </c:pt>
              </c:strCache>
            </c:strRef>
          </c:cat>
          <c:val>
            <c:numRef>
              <c:f>'pool Cong1 and CA2'!$O$11:$O$12</c:f>
              <c:numCache>
                <c:formatCode>General</c:formatCode>
                <c:ptCount val="2"/>
                <c:pt idx="0">
                  <c:v>3.125777777777778</c:v>
                </c:pt>
                <c:pt idx="1">
                  <c:v>3.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447-43E6-9E01-C5AA4C14FB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946527344"/>
        <c:axId val="946527904"/>
      </c:barChart>
      <c:catAx>
        <c:axId val="946527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946527904"/>
        <c:crosses val="autoZero"/>
        <c:auto val="1"/>
        <c:lblAlgn val="ctr"/>
        <c:lblOffset val="100"/>
        <c:noMultiLvlLbl val="0"/>
      </c:catAx>
      <c:valAx>
        <c:axId val="946527904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CH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ot</a:t>
                </a:r>
                <a:r>
                  <a:rPr lang="de-CH" sz="11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CH" sz="1100" baseline="0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omass</a:t>
                </a:r>
                <a:r>
                  <a:rPr lang="de-CH" sz="11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[g]</a:t>
                </a:r>
                <a:endParaRPr lang="de-CH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94652734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86717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77729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45999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30073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24004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67191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29479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56305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75508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11307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23390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DAC2D-5991-4157-B5F6-20695609139E}" type="datetimeFigureOut">
              <a:rPr lang="de-CH" smtClean="0"/>
              <a:t>21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66798B-38CB-4215-94DF-DC11139C1E71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02432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0" y="0"/>
            <a:ext cx="1761893" cy="5687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3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1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18211" y="673487"/>
            <a:ext cx="2918689" cy="1858004"/>
            <a:chOff x="218211" y="673487"/>
            <a:chExt cx="2918689" cy="1858004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/>
            </p:nvPr>
          </p:nvGraphicFramePr>
          <p:xfrm>
            <a:off x="218211" y="673487"/>
            <a:ext cx="2918689" cy="18580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1D1E780-FDF8-40FB-823D-A5839838BF5C}"/>
                </a:ext>
              </a:extLst>
            </p:cNvPr>
            <p:cNvSpPr txBox="1"/>
            <p:nvPr/>
          </p:nvSpPr>
          <p:spPr>
            <a:xfrm>
              <a:off x="968186" y="1398494"/>
              <a:ext cx="3688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6BC4832-B20B-4BB1-831D-E723166D7A19}"/>
                </a:ext>
              </a:extLst>
            </p:cNvPr>
            <p:cNvSpPr txBox="1"/>
            <p:nvPr/>
          </p:nvSpPr>
          <p:spPr>
            <a:xfrm>
              <a:off x="1308720" y="1032285"/>
              <a:ext cx="3688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A670176-D1DA-4E3E-BDC1-8ED54E747268}"/>
                </a:ext>
              </a:extLst>
            </p:cNvPr>
            <p:cNvSpPr txBox="1"/>
            <p:nvPr/>
          </p:nvSpPr>
          <p:spPr>
            <a:xfrm>
              <a:off x="1931970" y="832148"/>
              <a:ext cx="4752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0D3DE1D-CDB5-4FC2-B6AD-1DA70B38DCF3}"/>
                </a:ext>
              </a:extLst>
            </p:cNvPr>
            <p:cNvSpPr txBox="1"/>
            <p:nvPr/>
          </p:nvSpPr>
          <p:spPr>
            <a:xfrm>
              <a:off x="2241143" y="770675"/>
              <a:ext cx="4752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B5268C9-CE3B-4399-9A39-2E0AB9E39556}"/>
                </a:ext>
              </a:extLst>
            </p:cNvPr>
            <p:cNvSpPr txBox="1"/>
            <p:nvPr/>
          </p:nvSpPr>
          <p:spPr>
            <a:xfrm>
              <a:off x="2552128" y="770675"/>
              <a:ext cx="4752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240245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0" y="0"/>
            <a:ext cx="1761893" cy="5687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755934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37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1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CH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28099" y="439753"/>
            <a:ext cx="4798593" cy="3930332"/>
            <a:chOff x="228099" y="342768"/>
            <a:chExt cx="4798593" cy="3930332"/>
          </a:xfrm>
        </p:grpSpPr>
        <p:grpSp>
          <p:nvGrpSpPr>
            <p:cNvPr id="5" name="Group 4"/>
            <p:cNvGrpSpPr/>
            <p:nvPr/>
          </p:nvGrpSpPr>
          <p:grpSpPr>
            <a:xfrm>
              <a:off x="228099" y="568712"/>
              <a:ext cx="4798593" cy="3704388"/>
              <a:chOff x="299788" y="4753663"/>
              <a:chExt cx="4798593" cy="3704388"/>
            </a:xfrm>
          </p:grpSpPr>
          <p:graphicFrame>
            <p:nvGraphicFramePr>
              <p:cNvPr id="6" name="Chart 5"/>
              <p:cNvGraphicFramePr>
                <a:graphicFrameLocks/>
              </p:cNvGraphicFramePr>
              <p:nvPr>
                <p:extLst/>
              </p:nvPr>
            </p:nvGraphicFramePr>
            <p:xfrm>
              <a:off x="299788" y="4753663"/>
              <a:ext cx="2451242" cy="181459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7" name="Chart 6"/>
              <p:cNvGraphicFramePr>
                <a:graphicFrameLocks/>
              </p:cNvGraphicFramePr>
              <p:nvPr>
                <p:extLst/>
              </p:nvPr>
            </p:nvGraphicFramePr>
            <p:xfrm>
              <a:off x="2814880" y="4762451"/>
              <a:ext cx="2283501" cy="180580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8" name="Chart 7"/>
              <p:cNvGraphicFramePr>
                <a:graphicFrameLocks/>
              </p:cNvGraphicFramePr>
              <p:nvPr>
                <p:extLst/>
              </p:nvPr>
            </p:nvGraphicFramePr>
            <p:xfrm>
              <a:off x="455550" y="6643458"/>
              <a:ext cx="2139718" cy="18145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  <p:sp>
          <p:nvSpPr>
            <p:cNvPr id="9" name="TextBox 8"/>
            <p:cNvSpPr txBox="1"/>
            <p:nvPr/>
          </p:nvSpPr>
          <p:spPr>
            <a:xfrm>
              <a:off x="289588" y="342768"/>
              <a:ext cx="4253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777436" y="342768"/>
              <a:ext cx="4253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85766" y="2290102"/>
              <a:ext cx="4253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802654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Office PowerPoint</Application>
  <PresentationFormat>Custom</PresentationFormat>
  <Paragraphs>1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elle A. M. Robert</dc:creator>
  <cp:lastModifiedBy>Christelle A. M. Robert</cp:lastModifiedBy>
  <cp:revision>1</cp:revision>
  <dcterms:created xsi:type="dcterms:W3CDTF">2020-02-21T13:19:24Z</dcterms:created>
  <dcterms:modified xsi:type="dcterms:W3CDTF">2020-02-21T13:19:44Z</dcterms:modified>
</cp:coreProperties>
</file>